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6" roundtripDataSignature="AMtx7mgmtrqKyz7B7Vb4y5KpUcd67x+9a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iapositiva de título" type="title">
  <p:cSld name="TITLE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4" name="Google Shape;14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" name="Google Shape;15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6" name="Google Shape;16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2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vertical y texto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3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y objetos" type="obj">
  <p:cSld name="OBJECT">
    <p:spTree>
      <p:nvGrpSpPr>
        <p:cNvPr id="17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0" name="Google Shape;20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1" name="Google Shape;21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" name="Google Shape;22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cabezado de sección" type="secHead">
  <p:cSld name="SECTION_HEADER">
    <p:spTree>
      <p:nvGrpSpPr>
        <p:cNvPr id="23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5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26" name="Google Shape;26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" name="Google Shape;27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8" name="Google Shape;28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os objetos" type="twoObj">
  <p:cSld name="TWO_OBJECTS">
    <p:spTree>
      <p:nvGrpSpPr>
        <p:cNvPr id="29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6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2" name="Google Shape;32;p6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3" name="Google Shape;33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4" name="Google Shape;34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ción" type="twoTxTwoObj">
  <p:cSld name="TWO_OBJECTS_WITH_TEXT">
    <p:spTree>
      <p:nvGrpSpPr>
        <p:cNvPr id="36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7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39" name="Google Shape;39;p7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0" name="Google Shape;40;p7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1" name="Google Shape;41;p7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2" name="Google Shape;42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3" name="Google Shape;43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4" name="Google Shape;44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lo el título" type="titleOnly">
  <p:cSld name="TITLE_ONLY">
    <p:spTree>
      <p:nvGrpSpPr>
        <p:cNvPr id="45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9" name="Google Shape;49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n blanco" type="blank">
  <p:cSld name="BLANK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ido con título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0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0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n con título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1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2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A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hyperlink" Target="http://www.cruzi.pastuer.uy/" TargetMode="External"/><Relationship Id="rId4" Type="http://schemas.openxmlformats.org/officeDocument/2006/relationships/hyperlink" Target="http://www.cruzi.pastuer.uy/" TargetMode="External"/><Relationship Id="rId9" Type="http://schemas.openxmlformats.org/officeDocument/2006/relationships/image" Target="../media/image1.png"/><Relationship Id="rId5" Type="http://schemas.openxmlformats.org/officeDocument/2006/relationships/hyperlink" Target="http://www.cruzi.pastuer.uy/" TargetMode="External"/><Relationship Id="rId6" Type="http://schemas.openxmlformats.org/officeDocument/2006/relationships/image" Target="../media/image4.png"/><Relationship Id="rId7" Type="http://schemas.openxmlformats.org/officeDocument/2006/relationships/image" Target="../media/image3.png"/><Relationship Id="rId8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414867" y="121786"/>
            <a:ext cx="9982200" cy="6465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</a:t>
            </a: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b="0" i="1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. cruzi </a:t>
            </a: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ebpage (</a:t>
            </a:r>
            <a:r>
              <a:rPr b="0" i="0" lang="es-AR" sz="1800" u="sng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hlinkClick r:id="rId3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www.cruzi.past</a:t>
            </a:r>
            <a:r>
              <a:rPr lang="es-AR" sz="18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hlinkClick r:id="rId4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eu</a:t>
            </a:r>
            <a:r>
              <a:rPr b="0" i="0" lang="es-AR" sz="1800" u="sng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hlinkClick r:id="rId5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r.uy/</a:t>
            </a: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. A. Home page. B. Dm28c_T2T genome visualization. C. and D. Visualization of circos </a:t>
            </a: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d</a:t>
            </a: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dotplot </a:t>
            </a: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spectively</a:t>
            </a:r>
            <a:r>
              <a:rPr b="0" i="0" lang="es-AR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85" name="Google Shape;85;p1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304800" y="853635"/>
            <a:ext cx="7502297" cy="3016643"/>
          </a:xfrm>
          <a:prstGeom prst="rect">
            <a:avLst/>
          </a:prstGeom>
          <a:noFill/>
          <a:ln>
            <a:noFill/>
          </a:ln>
        </p:spPr>
      </p:pic>
      <p:pic>
        <p:nvPicPr>
          <p:cNvPr id="86" name="Google Shape;86;p1"/>
          <p:cNvPicPr preferRelativeResize="0"/>
          <p:nvPr/>
        </p:nvPicPr>
        <p:blipFill rotWithShape="1">
          <a:blip r:embed="rId7">
            <a:alphaModFix/>
          </a:blip>
          <a:srcRect b="0" l="0" r="0" t="0"/>
          <a:stretch/>
        </p:blipFill>
        <p:spPr>
          <a:xfrm>
            <a:off x="1225126" y="4041314"/>
            <a:ext cx="5661644" cy="2716082"/>
          </a:xfrm>
          <a:prstGeom prst="rect">
            <a:avLst/>
          </a:prstGeom>
          <a:noFill/>
          <a:ln>
            <a:noFill/>
          </a:ln>
        </p:spPr>
      </p:pic>
      <p:pic>
        <p:nvPicPr>
          <p:cNvPr id="87" name="Google Shape;87;p1"/>
          <p:cNvPicPr preferRelativeResize="0"/>
          <p:nvPr/>
        </p:nvPicPr>
        <p:blipFill rotWithShape="1">
          <a:blip r:embed="rId8">
            <a:alphaModFix/>
          </a:blip>
          <a:srcRect b="0" l="0" r="0" t="0"/>
          <a:stretch/>
        </p:blipFill>
        <p:spPr>
          <a:xfrm>
            <a:off x="8113492" y="1568470"/>
            <a:ext cx="3514945" cy="2230437"/>
          </a:xfrm>
          <a:prstGeom prst="rect">
            <a:avLst/>
          </a:prstGeom>
          <a:noFill/>
          <a:ln>
            <a:noFill/>
          </a:ln>
        </p:spPr>
      </p:pic>
      <p:pic>
        <p:nvPicPr>
          <p:cNvPr id="88" name="Google Shape;88;p1"/>
          <p:cNvPicPr preferRelativeResize="0"/>
          <p:nvPr/>
        </p:nvPicPr>
        <p:blipFill rotWithShape="1">
          <a:blip r:embed="rId9">
            <a:alphaModFix/>
          </a:blip>
          <a:srcRect b="0" l="0" r="0" t="0"/>
          <a:stretch/>
        </p:blipFill>
        <p:spPr>
          <a:xfrm>
            <a:off x="8198160" y="3992460"/>
            <a:ext cx="3514945" cy="2813789"/>
          </a:xfrm>
          <a:prstGeom prst="rect">
            <a:avLst/>
          </a:prstGeom>
          <a:noFill/>
          <a:ln>
            <a:noFill/>
          </a:ln>
        </p:spPr>
      </p:pic>
      <p:sp>
        <p:nvSpPr>
          <p:cNvPr id="89" name="Google Shape;89;p1"/>
          <p:cNvSpPr txBox="1"/>
          <p:nvPr/>
        </p:nvSpPr>
        <p:spPr>
          <a:xfrm>
            <a:off x="266700" y="1036564"/>
            <a:ext cx="296333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1"/>
          <p:cNvSpPr txBox="1"/>
          <p:nvPr/>
        </p:nvSpPr>
        <p:spPr>
          <a:xfrm>
            <a:off x="124932" y="3966399"/>
            <a:ext cx="296333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1" name="Google Shape;91;p1"/>
          <p:cNvSpPr txBox="1"/>
          <p:nvPr/>
        </p:nvSpPr>
        <p:spPr>
          <a:xfrm>
            <a:off x="8049993" y="1221230"/>
            <a:ext cx="296333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2" name="Google Shape;92;p1"/>
          <p:cNvSpPr txBox="1"/>
          <p:nvPr/>
        </p:nvSpPr>
        <p:spPr>
          <a:xfrm>
            <a:off x="8113492" y="3597067"/>
            <a:ext cx="296333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s-A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2-12T13:37:53Z</dcterms:created>
  <dc:creator>Gonzalo Greif</dc:creator>
</cp:coreProperties>
</file>